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50" d="100"/>
          <a:sy n="50" d="100"/>
        </p:scale>
        <p:origin x="67" y="29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err="1"/>
              <a:t>Prevelence</a:t>
            </a:r>
            <a:r>
              <a:rPr lang="en-US" dirty="0"/>
              <a:t> of different patterns of </a:t>
            </a:r>
            <a:r>
              <a:rPr lang="en-US" dirty="0" err="1"/>
              <a:t>glucos</a:t>
            </a:r>
            <a:r>
              <a:rPr lang="en-US" dirty="0"/>
              <a:t> metabolism in the study cohort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cap="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/>
      <c:bar3DChart>
        <c:barDir val="bar"/>
        <c:grouping val="stacked"/>
        <c:varyColors val="0"/>
        <c:dLbls>
          <c:showLegendKey val="0"/>
          <c:showVal val="1"/>
          <c:showCatName val="0"/>
          <c:showSerName val="0"/>
          <c:showPercent val="0"/>
          <c:showBubbleSize val="0"/>
        </c:dLbls>
        <c:gapWidth val="79"/>
        <c:shape val="box"/>
        <c:axId val="540006704"/>
        <c:axId val="540007032"/>
        <c:axId val="0"/>
      </c:bar3DChart>
      <c:catAx>
        <c:axId val="54000670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500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40007032"/>
        <c:crosses val="autoZero"/>
        <c:auto val="1"/>
        <c:lblAlgn val="ctr"/>
        <c:lblOffset val="100"/>
        <c:noMultiLvlLbl val="0"/>
      </c:catAx>
      <c:valAx>
        <c:axId val="540007032"/>
        <c:scaling>
          <c:orientation val="minMax"/>
        </c:scaling>
        <c:delete val="1"/>
        <c:axPos val="b"/>
        <c:numFmt formatCode="0.00%" sourceLinked="1"/>
        <c:majorTickMark val="none"/>
        <c:minorTickMark val="none"/>
        <c:tickLblPos val="nextTo"/>
        <c:crossAx val="5400067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err="1"/>
              <a:t>PrevAlEnce</a:t>
            </a:r>
            <a:r>
              <a:rPr lang="en-US" dirty="0"/>
              <a:t> of different patterns of glucose metabolism in the </a:t>
            </a:r>
            <a:r>
              <a:rPr lang="en-US" dirty="0" err="1"/>
              <a:t>stUdy</a:t>
            </a:r>
            <a:r>
              <a:rPr lang="en-US" dirty="0"/>
              <a:t> group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cap="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/>
      <c:bar3DChart>
        <c:barDir val="bar"/>
        <c:grouping val="stack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  <a:sp3d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400" b="1" i="0" u="none" strike="noStrike" kern="1200" baseline="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Sheet1!$A$1:$A$6</c:f>
              <c:strCache>
                <c:ptCount val="6"/>
                <c:pt idx="0">
                  <c:v>NGT althrough follow up</c:v>
                </c:pt>
                <c:pt idx="1">
                  <c:v>Abnormal FPG/OGTT at any point</c:v>
                </c:pt>
                <c:pt idx="2">
                  <c:v>Impaired FPG/OGTT</c:v>
                </c:pt>
                <c:pt idx="3">
                  <c:v>NODAT</c:v>
                </c:pt>
                <c:pt idx="4">
                  <c:v>Transient hyperglycemia</c:v>
                </c:pt>
                <c:pt idx="5">
                  <c:v>Perminant hyperglycemia</c:v>
                </c:pt>
              </c:strCache>
            </c:strRef>
          </c:cat>
          <c:val>
            <c:numRef>
              <c:f>Sheet1!$B$1:$B$6</c:f>
              <c:numCache>
                <c:formatCode>0.00%</c:formatCode>
                <c:ptCount val="6"/>
                <c:pt idx="0">
                  <c:v>0.28599999999999998</c:v>
                </c:pt>
                <c:pt idx="1">
                  <c:v>0.71399999999999997</c:v>
                </c:pt>
                <c:pt idx="2">
                  <c:v>0.38100000000000001</c:v>
                </c:pt>
                <c:pt idx="3">
                  <c:v>0.33300000000000002</c:v>
                </c:pt>
                <c:pt idx="4">
                  <c:v>0.57099999999999995</c:v>
                </c:pt>
                <c:pt idx="5">
                  <c:v>0.1429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484-43F4-8382-AA507C8DCD47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79"/>
        <c:shape val="box"/>
        <c:axId val="543828544"/>
        <c:axId val="543829528"/>
        <c:axId val="0"/>
      </c:bar3DChart>
      <c:catAx>
        <c:axId val="54382854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43829528"/>
        <c:crosses val="autoZero"/>
        <c:auto val="1"/>
        <c:lblAlgn val="ctr"/>
        <c:lblOffset val="100"/>
        <c:noMultiLvlLbl val="0"/>
      </c:catAx>
      <c:valAx>
        <c:axId val="543829528"/>
        <c:scaling>
          <c:orientation val="minMax"/>
        </c:scaling>
        <c:delete val="1"/>
        <c:axPos val="b"/>
        <c:numFmt formatCode="0.00%" sourceLinked="1"/>
        <c:majorTickMark val="none"/>
        <c:minorTickMark val="none"/>
        <c:tickLblPos val="nextTo"/>
        <c:crossAx val="5438285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1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800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lt1"/>
    </cs:fontRef>
    <cs:defRPr sz="800" b="1" i="0" u="none" strike="noStrike" kern="1200" baseline="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8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31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800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lt1"/>
    </cs:fontRef>
    <cs:defRPr sz="800" b="1" i="0" u="none" strike="noStrike" kern="1200" baseline="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8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6289B1-C449-4B10-A594-644AF32F680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F5563A0-92C0-46CD-8051-71F64CA135E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F793DC-D1BA-49DB-A019-42F004F73C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B2F28-88A1-4C79-A0E9-355DF3019A81}" type="datetimeFigureOut">
              <a:rPr lang="en-US" smtClean="0"/>
              <a:t>6/1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08A867-4529-4829-854E-ED99DB350E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1CAF59-731F-4CF1-91CB-54810BC8F9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ADA22-E858-4F77-AE77-76042656F9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77125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F9B806-CD7C-4D25-B4D1-745FDDB85D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634C746-1A98-4945-BB01-3BAA1DE1A69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FEC7DB-9B10-4B3B-82D6-6643754BD6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B2F28-88A1-4C79-A0E9-355DF3019A81}" type="datetimeFigureOut">
              <a:rPr lang="en-US" smtClean="0"/>
              <a:t>6/1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D31C8D-4A20-4711-85ED-F535D98D02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C6B550-EE31-4D8F-B268-A97BE57473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ADA22-E858-4F77-AE77-76042656F9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80189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D6D6A81-DBBD-4799-9940-53C196BA0C2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8E3A102-D747-4D06-8E4D-38A9BF8AB0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8C3F2A-E736-4A28-A1A8-9E76F757B5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B2F28-88A1-4C79-A0E9-355DF3019A81}" type="datetimeFigureOut">
              <a:rPr lang="en-US" smtClean="0"/>
              <a:t>6/1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0A8638-B3F1-452F-8593-3D5F4D20DB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8782FD-7A1F-49D1-BBF0-01AF7FAAD1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ADA22-E858-4F77-AE77-76042656F9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8202584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40965713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80958E-CEDC-4E10-8831-A626248EC6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9468B9-986C-4BA8-A7E9-BBB3505D180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DD4432-FE6D-4B0A-8049-CA48761CF2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B2F28-88A1-4C79-A0E9-355DF3019A81}" type="datetimeFigureOut">
              <a:rPr lang="en-US" smtClean="0"/>
              <a:t>6/1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47B8DD-1450-4B56-9CDB-48EEA285B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77A0B3-B3C4-48E3-A030-035CF74A55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ADA22-E858-4F77-AE77-76042656F9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03043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C1DC73-F511-4439-8945-E4CE9F3FC4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0693E84-1FFB-438B-AEF0-CCAED5E5D9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C195DA-A6B0-4D74-B06E-0E67500383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B2F28-88A1-4C79-A0E9-355DF3019A81}" type="datetimeFigureOut">
              <a:rPr lang="en-US" smtClean="0"/>
              <a:t>6/1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E914CF-FB80-4C84-A92A-507D000DA0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FF0ED0-3CEF-43D8-81E0-945A15CEA5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ADA22-E858-4F77-AE77-76042656F9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83866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4DA060-C21E-4BD5-BE0F-18EE4A2739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815DB5D-3CEC-4818-A69D-08D39C373B4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4E89AE1-E7B9-4871-959B-E034B259CD1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F0C179F-3B7F-422E-930F-2D184C188C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B2F28-88A1-4C79-A0E9-355DF3019A81}" type="datetimeFigureOut">
              <a:rPr lang="en-US" smtClean="0"/>
              <a:t>6/13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CA4E13E-92DC-4885-949F-1D2AD99169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B189C4F-D064-4636-8334-225B59F044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ADA22-E858-4F77-AE77-76042656F9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38531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EFD593-31E4-4ECA-B372-62FDD428CA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1F4198A-926D-492E-B59C-7692A8B8DB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3A23ECF-8AC6-43CF-AC70-C4D3D81B6E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EDD0D17-9791-456A-917A-7425B8D3F4C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2103970-96E4-4972-B5F8-31BBB222813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B6AD22B-A3DE-4951-8534-C12A26BA12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B2F28-88A1-4C79-A0E9-355DF3019A81}" type="datetimeFigureOut">
              <a:rPr lang="en-US" smtClean="0"/>
              <a:t>6/13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8EF1042-2DD7-4DD5-927D-E2B46DB28E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2BAB4BB-DEFE-4417-9319-2EE983A647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ADA22-E858-4F77-AE77-76042656F9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35869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D7B711-C08B-49F1-ACA2-E3DCB29BE4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5BE4385-D4CE-4C77-9E34-DC2980B072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B2F28-88A1-4C79-A0E9-355DF3019A81}" type="datetimeFigureOut">
              <a:rPr lang="en-US" smtClean="0"/>
              <a:t>6/13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DAC54F9-3AB0-4D48-A4CD-E8C579FCC4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D321B10-51BC-4129-B682-CADD360DF1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ADA22-E858-4F77-AE77-76042656F9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27691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E1FEA07-FF29-44F0-A54F-54B89EA44C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B2F28-88A1-4C79-A0E9-355DF3019A81}" type="datetimeFigureOut">
              <a:rPr lang="en-US" smtClean="0"/>
              <a:t>6/13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80107D3-3A4C-4F20-81E3-4AD7734102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171D4B2-92A2-442B-814C-9ADB57F2B2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ADA22-E858-4F77-AE77-76042656F9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80387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604063-4333-4BE1-8D46-851F2E56AC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EB1038D-34DB-4C3F-BD36-FFE1BA47B49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13A2F6B-3863-40EF-9D6A-46980E8B6A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B1E6BE4-1EFB-4300-9CCB-CC93EE0241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B2F28-88A1-4C79-A0E9-355DF3019A81}" type="datetimeFigureOut">
              <a:rPr lang="en-US" smtClean="0"/>
              <a:t>6/13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39E967-1E83-4262-8B20-F2A52B705F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5CCD36E-5C38-4480-8F58-DCDFD7D980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ADA22-E858-4F77-AE77-76042656F9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55199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F8DC63-C1D8-44A4-96A4-F6A766D63F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55B8FAC-9107-49C9-B830-96FE18D025C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8FCBC77-8AA9-44B9-8518-9CAA0C2FD01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E0D9FB-C193-42DE-B67C-B71D183C88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B2F28-88A1-4C79-A0E9-355DF3019A81}" type="datetimeFigureOut">
              <a:rPr lang="en-US" smtClean="0"/>
              <a:t>6/13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794C09D-A938-4880-8C7D-E2625C6D8D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B5C646F-A055-4C27-BA4E-513D426475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ADA22-E858-4F77-AE77-76042656F9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91342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0A85DB2-6C06-4F36-B96E-A2B2E4317E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E7B2250-EE13-45DB-B7A7-663F9E18F9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D439A4-31E9-440A-B11F-B8371D5CD9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4B2F28-88A1-4C79-A0E9-355DF3019A81}" type="datetimeFigureOut">
              <a:rPr lang="en-US" smtClean="0"/>
              <a:t>6/1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E4E84C-FFB6-4269-A51B-32152CADA2A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717FB8-A072-45AA-8249-C58C39E7EDB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EADA22-E858-4F77-AE77-76042656F9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55323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 algn="l">
              <a:lnSpc>
                <a:spcPct val="100000"/>
              </a:lnSpc>
              <a:spcBef>
                <a:spcPts val="0"/>
              </a:spcBef>
              <a:spcAft>
                <a:spcPts val="1000"/>
              </a:spcAft>
            </a:pPr>
            <a:r>
              <a:rPr lang="en-GB" sz="3200" dirty="0">
                <a:solidFill>
                  <a:schemeClr val="bg1">
                    <a:lumMod val="9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Monitoring of blood glucose after </a:t>
            </a:r>
            <a:r>
              <a:rPr lang="en-GB" sz="3200" dirty="0" err="1">
                <a:solidFill>
                  <a:schemeClr val="bg1">
                    <a:lumMod val="9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ediatric</a:t>
            </a:r>
            <a:r>
              <a:rPr lang="en-GB" sz="3200" dirty="0">
                <a:solidFill>
                  <a:schemeClr val="bg1">
                    <a:lumMod val="9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kidney </a:t>
            </a:r>
            <a:br>
              <a:rPr lang="en-GB" sz="3200">
                <a:solidFill>
                  <a:schemeClr val="bg1">
                    <a:lumMod val="9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</a:br>
            <a:r>
              <a:rPr lang="en-GB" sz="3200">
                <a:solidFill>
                  <a:schemeClr val="bg1">
                    <a:lumMod val="9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transplantation</a:t>
            </a:r>
            <a:r>
              <a:rPr lang="en-GB" sz="3200" dirty="0">
                <a:solidFill>
                  <a:schemeClr val="bg1">
                    <a:lumMod val="9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: a longitudinal cohort study</a:t>
            </a:r>
            <a:endParaRPr lang="en-US" sz="3200" dirty="0">
              <a:solidFill>
                <a:schemeClr val="bg1">
                  <a:lumMod val="95000"/>
                </a:schemeClr>
              </a:solidFill>
              <a:effectLst/>
              <a:latin typeface="Calibri" panose="020F0502020204030204" pitchFamily="34" charset="0"/>
              <a:ea typeface="Times New Roman" panose="02020603050405020304" pitchFamily="18" charset="0"/>
              <a:cs typeface="Calibri" panose="020F050202020403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sz="2000" dirty="0">
                <a:solidFill>
                  <a:schemeClr val="bg1">
                    <a:lumMod val="95000"/>
                  </a:schemeClr>
                </a:solidFill>
              </a:rPr>
              <a:t>: A</a:t>
            </a:r>
            <a:r>
              <a:rPr lang="en-GB" sz="2000" dirty="0">
                <a:solidFill>
                  <a:schemeClr val="bg1">
                    <a:lumMod val="95000"/>
                  </a:schemeClr>
                </a:solidFill>
                <a:effectLst/>
                <a:ea typeface="Calibri" panose="020F0502020204030204" pitchFamily="34" charset="0"/>
              </a:rPr>
              <a:t>nalysis of glucose metabolism </a:t>
            </a:r>
            <a:r>
              <a:rPr kumimoji="0" lang="en-GB" sz="2000" b="0" i="0" u="none" strike="noStrike" kern="1200" cap="none" spc="0" normalizeH="0" baseline="0" noProof="0" dirty="0">
                <a:ln>
                  <a:noFill/>
                </a:ln>
                <a:solidFill>
                  <a:schemeClr val="bg1">
                    <a:lumMod val="95000"/>
                  </a:schemeClr>
                </a:solidFill>
                <a:effectLst/>
                <a:uLnTx/>
                <a:uFillTx/>
                <a:ea typeface="Calibri" panose="020F0502020204030204" pitchFamily="34" charset="0"/>
                <a:cs typeface="+mn-cs"/>
              </a:rPr>
              <a:t>dynamics </a:t>
            </a:r>
            <a:r>
              <a:rPr lang="en-GB" sz="2000" dirty="0">
                <a:solidFill>
                  <a:schemeClr val="bg1">
                    <a:lumMod val="95000"/>
                  </a:schemeClr>
                </a:solidFill>
                <a:effectLst/>
                <a:ea typeface="Calibri" panose="020F0502020204030204" pitchFamily="34" charset="0"/>
              </a:rPr>
              <a:t>in the first post-transplantation year is crucial </a:t>
            </a:r>
            <a:endParaRPr lang="en-GB" sz="2000" dirty="0">
              <a:solidFill>
                <a:schemeClr val="bg1">
                  <a:lumMod val="95000"/>
                </a:schemeClr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 Salah et al. 2022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34259" y="5732235"/>
            <a:ext cx="725931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GB" sz="2000" dirty="0">
                <a:solidFill>
                  <a:schemeClr val="bg1">
                    <a:lumMod val="95000"/>
                  </a:schemeClr>
                </a:solidFill>
              </a:rPr>
              <a:t>U</a:t>
            </a:r>
            <a:r>
              <a:rPr lang="en-GB" sz="2000" dirty="0">
                <a:solidFill>
                  <a:schemeClr val="bg1">
                    <a:lumMod val="95000"/>
                  </a:schemeClr>
                </a:solidFill>
                <a:effectLst/>
                <a:ea typeface="Calibri" panose="020F0502020204030204" pitchFamily="34" charset="0"/>
              </a:rPr>
              <a:t>p to 71.4% of recipients experience abnormal glucose metabolism at any point in the first year with peak onset of NODAT in the first month</a:t>
            </a:r>
            <a:r>
              <a:rPr lang="en-GB" sz="2000" dirty="0">
                <a:solidFill>
                  <a:schemeClr val="bg1">
                    <a:lumMod val="95000"/>
                  </a:schemeClr>
                </a:solidFill>
                <a:ea typeface="Calibri" panose="020F0502020204030204" pitchFamily="34" charset="0"/>
              </a:rPr>
              <a:t>.</a:t>
            </a:r>
            <a:r>
              <a:rPr lang="en-GB" sz="2000" dirty="0">
                <a:solidFill>
                  <a:schemeClr val="bg1">
                    <a:lumMod val="95000"/>
                  </a:schemeClr>
                </a:solidFill>
                <a:effectLst/>
                <a:ea typeface="Calibri" panose="020F0502020204030204" pitchFamily="34" charset="0"/>
              </a:rPr>
              <a:t> </a:t>
            </a:r>
            <a:endParaRPr lang="en-GB" dirty="0">
              <a:solidFill>
                <a:schemeClr val="bg1">
                  <a:lumMod val="95000"/>
                </a:schemeClr>
              </a:solidFill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F997CF6D-DFE2-4CE0-BC7F-30ECEBD1C9BB}"/>
              </a:ext>
            </a:extLst>
          </p:cNvPr>
          <p:cNvSpPr/>
          <p:nvPr/>
        </p:nvSpPr>
        <p:spPr>
          <a:xfrm>
            <a:off x="124205" y="2216539"/>
            <a:ext cx="1564895" cy="2037663"/>
          </a:xfrm>
          <a:prstGeom prst="rect">
            <a:avLst/>
          </a:prstGeom>
          <a:solidFill>
            <a:srgbClr val="0070C0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dirty="0">
                <a:solidFill>
                  <a:schemeClr val="bg1"/>
                </a:solidFill>
              </a:rPr>
              <a:t>21 consecutive kidney transplant recipients (cohort)</a:t>
            </a:r>
          </a:p>
        </p:txBody>
      </p: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4066AF06-9287-47FD-B160-0D873713A809}"/>
              </a:ext>
            </a:extLst>
          </p:cNvPr>
          <p:cNvCxnSpPr>
            <a:cxnSpLocks/>
          </p:cNvCxnSpPr>
          <p:nvPr/>
        </p:nvCxnSpPr>
        <p:spPr>
          <a:xfrm flipV="1">
            <a:off x="1690276" y="2106172"/>
            <a:ext cx="731910" cy="913958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Rectangle 12">
            <a:extLst>
              <a:ext uri="{FF2B5EF4-FFF2-40B4-BE49-F238E27FC236}">
                <a16:creationId xmlns:a16="http://schemas.microsoft.com/office/drawing/2014/main" id="{C6F13926-AE57-4F7C-A136-33A9F65CB11F}"/>
              </a:ext>
            </a:extLst>
          </p:cNvPr>
          <p:cNvSpPr/>
          <p:nvPr/>
        </p:nvSpPr>
        <p:spPr>
          <a:xfrm>
            <a:off x="2422186" y="1784351"/>
            <a:ext cx="2858475" cy="796041"/>
          </a:xfrm>
          <a:prstGeom prst="rect">
            <a:avLst/>
          </a:prstGeom>
          <a:solidFill>
            <a:srgbClr val="0070C0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dirty="0">
                <a:solidFill>
                  <a:schemeClr val="bg1"/>
                </a:solidFill>
              </a:rPr>
              <a:t>Clinical/laboratory assessment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FE483AE2-CF2A-44F0-B211-9D6EA3B3DE26}"/>
              </a:ext>
            </a:extLst>
          </p:cNvPr>
          <p:cNvCxnSpPr>
            <a:cxnSpLocks/>
          </p:cNvCxnSpPr>
          <p:nvPr/>
        </p:nvCxnSpPr>
        <p:spPr>
          <a:xfrm flipV="1">
            <a:off x="1636345" y="2982866"/>
            <a:ext cx="785841" cy="4647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0C3022AE-5351-4FA5-A8B3-C6D5A34B0DF5}"/>
              </a:ext>
            </a:extLst>
          </p:cNvPr>
          <p:cNvCxnSpPr>
            <a:cxnSpLocks/>
          </p:cNvCxnSpPr>
          <p:nvPr/>
        </p:nvCxnSpPr>
        <p:spPr>
          <a:xfrm>
            <a:off x="1687851" y="3083635"/>
            <a:ext cx="719384" cy="852125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Rectangle 29">
            <a:extLst>
              <a:ext uri="{FF2B5EF4-FFF2-40B4-BE49-F238E27FC236}">
                <a16:creationId xmlns:a16="http://schemas.microsoft.com/office/drawing/2014/main" id="{406A3CA7-9184-4846-B445-B01AD29FF3E4}"/>
              </a:ext>
            </a:extLst>
          </p:cNvPr>
          <p:cNvSpPr/>
          <p:nvPr/>
        </p:nvSpPr>
        <p:spPr>
          <a:xfrm>
            <a:off x="2430525" y="2622224"/>
            <a:ext cx="2862836" cy="640814"/>
          </a:xfrm>
          <a:prstGeom prst="rect">
            <a:avLst/>
          </a:prstGeom>
          <a:solidFill>
            <a:srgbClr val="0070C0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dirty="0">
                <a:solidFill>
                  <a:schemeClr val="bg1"/>
                </a:solidFill>
              </a:rPr>
              <a:t>Transplantation/ immunosuppression data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EBAEDFD7-F748-4FB5-AF93-B4DB857CB2EA}"/>
              </a:ext>
            </a:extLst>
          </p:cNvPr>
          <p:cNvSpPr/>
          <p:nvPr/>
        </p:nvSpPr>
        <p:spPr>
          <a:xfrm>
            <a:off x="2424010" y="3307806"/>
            <a:ext cx="2869351" cy="2203427"/>
          </a:xfrm>
          <a:prstGeom prst="rect">
            <a:avLst/>
          </a:prstGeom>
          <a:solidFill>
            <a:srgbClr val="0070C0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dirty="0">
                <a:solidFill>
                  <a:schemeClr val="bg1"/>
                </a:solidFill>
              </a:rPr>
              <a:t>Blood glucose monitoring at fixed time intervals by FPG, OGTT:</a:t>
            </a:r>
          </a:p>
          <a:p>
            <a:r>
              <a:rPr lang="en-US" sz="2000" dirty="0">
                <a:solidFill>
                  <a:schemeClr val="bg1"/>
                </a:solidFill>
              </a:rPr>
              <a:t>Weekly during the first month then every three months till the end of the first year</a:t>
            </a:r>
          </a:p>
        </p:txBody>
      </p:sp>
      <p:sp>
        <p:nvSpPr>
          <p:cNvPr id="34" name="Rectangle 2">
            <a:extLst>
              <a:ext uri="{FF2B5EF4-FFF2-40B4-BE49-F238E27FC236}">
                <a16:creationId xmlns:a16="http://schemas.microsoft.com/office/drawing/2014/main" id="{73D24575-E804-4B64-9CAF-C0E9245B0E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8880095" y="1686630"/>
            <a:ext cx="7640929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36" name="Rectangle 4">
            <a:extLst>
              <a:ext uri="{FF2B5EF4-FFF2-40B4-BE49-F238E27FC236}">
                <a16:creationId xmlns:a16="http://schemas.microsoft.com/office/drawing/2014/main" id="{8F0CD7DC-BB1A-4572-9D88-E231F529E87C}"/>
              </a:ext>
            </a:extLst>
          </p:cNvPr>
          <p:cNvSpPr>
            <a:spLocks noChangeArrowheads="1"/>
          </p:cNvSpPr>
          <p:nvPr/>
        </p:nvSpPr>
        <p:spPr bwMode="auto">
          <a:xfrm>
            <a:off x="8410195" y="3396341"/>
            <a:ext cx="8800241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29" name="Chart 28">
            <a:extLst>
              <a:ext uri="{FF2B5EF4-FFF2-40B4-BE49-F238E27FC236}">
                <a16:creationId xmlns:a16="http://schemas.microsoft.com/office/drawing/2014/main" id="{47BBB9F0-44FF-0D4D-3C55-32F96EA18A6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1171550"/>
              </p:ext>
            </p:extLst>
          </p:nvPr>
        </p:nvGraphicFramePr>
        <p:xfrm>
          <a:off x="5316651" y="1686631"/>
          <a:ext cx="6701901" cy="39008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7" name="Chart 16">
            <a:extLst>
              <a:ext uri="{FF2B5EF4-FFF2-40B4-BE49-F238E27FC236}">
                <a16:creationId xmlns:a16="http://schemas.microsoft.com/office/drawing/2014/main" id="{1EC5575E-851B-1377-A554-FD8C6ECD0A4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6197387"/>
              </p:ext>
            </p:extLst>
          </p:nvPr>
        </p:nvGraphicFramePr>
        <p:xfrm>
          <a:off x="5385582" y="1796803"/>
          <a:ext cx="6701900" cy="37003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99A06643-7818-4A62-90E5-E74872CFB664}"/>
              </a:ext>
            </a:extLst>
          </p:cNvPr>
          <p:cNvSpPr txBox="1"/>
          <p:nvPr/>
        </p:nvSpPr>
        <p:spPr>
          <a:xfrm>
            <a:off x="5471159" y="2591744"/>
            <a:ext cx="3378455" cy="267060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>
              <a:lnSpc>
                <a:spcPct val="150000"/>
              </a:lnSpc>
              <a:spcBef>
                <a:spcPts val="150"/>
              </a:spcBef>
            </a:pPr>
            <a:r>
              <a:rPr lang="en-GB" dirty="0"/>
              <a:t>Permanent </a:t>
            </a:r>
            <a:r>
              <a:rPr lang="en-GB" dirty="0" err="1"/>
              <a:t>hyperglycemia</a:t>
            </a:r>
            <a:endParaRPr lang="en-GB" dirty="0"/>
          </a:p>
          <a:p>
            <a:pPr algn="r">
              <a:lnSpc>
                <a:spcPct val="150000"/>
              </a:lnSpc>
              <a:spcBef>
                <a:spcPts val="150"/>
              </a:spcBef>
            </a:pPr>
            <a:r>
              <a:rPr lang="en-GB" dirty="0"/>
              <a:t>Transient </a:t>
            </a:r>
            <a:r>
              <a:rPr lang="en-GB" dirty="0" err="1"/>
              <a:t>hyperglycemia</a:t>
            </a:r>
            <a:endParaRPr lang="en-GB" dirty="0"/>
          </a:p>
          <a:p>
            <a:pPr algn="r">
              <a:lnSpc>
                <a:spcPct val="150000"/>
              </a:lnSpc>
              <a:spcBef>
                <a:spcPts val="150"/>
              </a:spcBef>
            </a:pPr>
            <a:r>
              <a:rPr lang="en-GB" dirty="0"/>
              <a:t>NODAT</a:t>
            </a:r>
          </a:p>
          <a:p>
            <a:pPr algn="r">
              <a:lnSpc>
                <a:spcPct val="150000"/>
              </a:lnSpc>
              <a:spcBef>
                <a:spcPts val="150"/>
              </a:spcBef>
            </a:pPr>
            <a:r>
              <a:rPr lang="en-GB" dirty="0"/>
              <a:t>Impaired FPG/OGTT</a:t>
            </a:r>
          </a:p>
          <a:p>
            <a:pPr algn="r">
              <a:lnSpc>
                <a:spcPct val="150000"/>
              </a:lnSpc>
              <a:spcBef>
                <a:spcPts val="150"/>
              </a:spcBef>
            </a:pPr>
            <a:r>
              <a:rPr lang="en-GB" dirty="0"/>
              <a:t>Abnormal FPG/OGTT at any point</a:t>
            </a:r>
          </a:p>
          <a:p>
            <a:pPr algn="r">
              <a:lnSpc>
                <a:spcPct val="150000"/>
              </a:lnSpc>
              <a:spcBef>
                <a:spcPts val="150"/>
              </a:spcBef>
            </a:pPr>
            <a:r>
              <a:rPr lang="en-GB" dirty="0"/>
              <a:t>NGT throughout follow up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814</TotalTime>
  <Words>155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DoaaSalah</dc:creator>
  <cp:lastModifiedBy>Laycock, Joseph</cp:lastModifiedBy>
  <cp:revision>6</cp:revision>
  <dcterms:created xsi:type="dcterms:W3CDTF">2022-05-05T21:10:30Z</dcterms:created>
  <dcterms:modified xsi:type="dcterms:W3CDTF">2022-06-15T12:40:53Z</dcterms:modified>
</cp:coreProperties>
</file>